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18D7729-4765-4D74-AAC8-093A1D1880C2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7A2FD9D-52F3-4EA0-9360-7DF3DB1F77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A47BBC5-1A91-4609-8494-FE8071CB79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2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54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2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54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F74E690-1F0C-4757-A81E-98FF43E82178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68FA0A5-723F-43D3-B708-5C5AA89AD7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D413019-4663-4207-A1F7-A3373E61F1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D80BC67-E0CE-45E6-9A7F-7218F79CB4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9C739B4-7607-4410-A710-F769E108758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366480"/>
            <a:ext cx="6170400" cy="705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03D49F9-E4E1-4F79-87C1-EA116F4875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C4157D8-D39A-4DB9-8E04-9DC59C9CA4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F438037-78A1-4471-B859-D2CB470D70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D2597DB-5730-4B9E-8B3C-7A9EAF9BAE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3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0/3/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2343240" y="8475840"/>
            <a:ext cx="2171520" cy="48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4915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23D14E86-4BA8-4B50-979A-1CE23258DE9D}" type="slidenum">
              <a:rPr b="0" lang="en-US" sz="18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914400" y="1015920"/>
            <a:ext cx="3886200" cy="1727280"/>
          </a:xfrm>
          <a:prstGeom prst="roundRect">
            <a:avLst>
              <a:gd name="adj" fmla="val 16667"/>
            </a:avLst>
          </a:prstGeom>
          <a:noFill/>
          <a:ln w="57240">
            <a:solidFill>
              <a:srgbClr val="3a5f8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2" name=""/>
          <p:cNvCxnSpPr/>
          <p:nvPr/>
        </p:nvCxnSpPr>
        <p:spPr>
          <a:xfrm>
            <a:off x="2714760" y="4876920"/>
            <a:ext cx="2160" cy="915120"/>
          </a:xfrm>
          <a:prstGeom prst="bentConnector3">
            <a:avLst>
              <a:gd name="adj1" fmla="val 40000"/>
            </a:avLst>
          </a:prstGeom>
          <a:ln w="76320">
            <a:solidFill>
              <a:srgbClr val="000000"/>
            </a:solidFill>
            <a:round/>
            <a:tailEnd len="med" type="triangle" w="med"/>
          </a:ln>
        </p:spPr>
      </p:cxnSp>
      <p:sp>
        <p:nvSpPr>
          <p:cNvPr id="43" name=""/>
          <p:cNvSpPr/>
          <p:nvPr/>
        </p:nvSpPr>
        <p:spPr>
          <a:xfrm>
            <a:off x="1116000" y="6772320"/>
            <a:ext cx="3705120" cy="1727280"/>
          </a:xfrm>
          <a:prstGeom prst="roundRect">
            <a:avLst>
              <a:gd name="adj" fmla="val 16667"/>
            </a:avLst>
          </a:prstGeom>
          <a:noFill/>
          <a:ln w="57240">
            <a:solidFill>
              <a:srgbClr val="3a5f8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4" name=""/>
          <p:cNvCxnSpPr/>
          <p:nvPr/>
        </p:nvCxnSpPr>
        <p:spPr>
          <a:xfrm>
            <a:off x="2714760" y="1932120"/>
            <a:ext cx="2160" cy="915120"/>
          </a:xfrm>
          <a:prstGeom prst="bentConnector3">
            <a:avLst>
              <a:gd name="adj1" fmla="val 40000"/>
            </a:avLst>
          </a:prstGeom>
          <a:ln w="76320">
            <a:solidFill>
              <a:srgbClr val="000000"/>
            </a:solidFill>
            <a:round/>
            <a:tailEnd len="med" type="triangle" w="med"/>
          </a:ln>
        </p:spPr>
      </p:cxnSp>
      <p:sp>
        <p:nvSpPr>
          <p:cNvPr id="45" name=""/>
          <p:cNvSpPr/>
          <p:nvPr/>
        </p:nvSpPr>
        <p:spPr>
          <a:xfrm>
            <a:off x="329400" y="76320"/>
            <a:ext cx="5154840" cy="68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dditional file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2: Figure S1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trategy used to develop a LIPS diagnostic test for TB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101600" y="1263600"/>
            <a:ext cx="3681360" cy="123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rst Stage screening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Individually test 24 MTB proteins with cohort 1.  Selected proteins also tested with cohort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899360" y="4108320"/>
            <a:ext cx="2561040" cy="960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econd Stage screening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Confirm 10 MTB protei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Cohort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581480" y="7315200"/>
            <a:ext cx="2777400" cy="68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Use 7 Antigen mixture wit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cohort 2 and cohort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9" name=""/>
          <p:cNvCxnSpPr/>
          <p:nvPr/>
        </p:nvCxnSpPr>
        <p:spPr>
          <a:xfrm>
            <a:off x="2200320" y="5335560"/>
            <a:ext cx="658080" cy="457920"/>
          </a:xfrm>
          <a:prstGeom prst="bentConnector3">
            <a:avLst>
              <a:gd name="adj1" fmla="val 49972"/>
            </a:avLst>
          </a:prstGeom>
          <a:ln w="38160">
            <a:solidFill>
              <a:srgbClr val="000000"/>
            </a:solidFill>
            <a:round/>
            <a:tailEnd len="med" type="triangle" w="med"/>
          </a:ln>
        </p:spPr>
      </p:cxnSp>
      <p:sp>
        <p:nvSpPr>
          <p:cNvPr id="50" name=""/>
          <p:cNvSpPr/>
          <p:nvPr/>
        </p:nvSpPr>
        <p:spPr>
          <a:xfrm>
            <a:off x="3609360" y="6002280"/>
            <a:ext cx="3192120" cy="502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t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Three proteins  (cfp10, Tb-16.3 and MPT64) no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needed for simple and sensitive diagnosi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101600" y="3886200"/>
            <a:ext cx="3705480" cy="1727280"/>
          </a:xfrm>
          <a:prstGeom prst="roundRect">
            <a:avLst>
              <a:gd name="adj" fmla="val 16667"/>
            </a:avLst>
          </a:prstGeom>
          <a:noFill/>
          <a:ln w="57240">
            <a:solidFill>
              <a:srgbClr val="3a5f8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dcterms:modified xsi:type="dcterms:W3CDTF">2015-10-03T02:42:56Z</dcterms:modified>
  <cp:revision>0</cp:revision>
  <dc:subject/>
  <dc:title/>
</cp:coreProperties>
</file>